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oleObject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61" r:id="rId2"/>
    <p:sldId id="263" r:id="rId3"/>
    <p:sldId id="262" r:id="rId4"/>
    <p:sldId id="256" r:id="rId5"/>
    <p:sldId id="269" r:id="rId6"/>
    <p:sldId id="270" r:id="rId7"/>
    <p:sldId id="257" r:id="rId8"/>
    <p:sldId id="271" r:id="rId9"/>
    <p:sldId id="265" r:id="rId10"/>
    <p:sldId id="264" r:id="rId11"/>
    <p:sldId id="260" r:id="rId1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569" autoAdjust="0"/>
    <p:restoredTop sz="94660"/>
  </p:normalViewPr>
  <p:slideViewPr>
    <p:cSldViewPr snapToGrid="0">
      <p:cViewPr>
        <p:scale>
          <a:sx n="92" d="100"/>
          <a:sy n="92" d="100"/>
        </p:scale>
        <p:origin x="144" y="30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notesMaster" Target="notesMasters/notesMaster1.xml"/><Relationship Id="rId14" Type="http://schemas.openxmlformats.org/officeDocument/2006/relationships/presProps" Target="presProps.xml"/><Relationship Id="rId15" Type="http://schemas.openxmlformats.org/officeDocument/2006/relationships/viewProps" Target="viewProps.xml"/><Relationship Id="rId16" Type="http://schemas.openxmlformats.org/officeDocument/2006/relationships/theme" Target="theme/theme1.xml"/><Relationship Id="rId1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4" Type="http://schemas.openxmlformats.org/officeDocument/2006/relationships/oleObject" Target="../embeddings/oleObject1.bin"/><Relationship Id="rId1" Type="http://schemas.microsoft.com/office/2011/relationships/chartStyle" Target="style1.xml"/><Relationship Id="rId2" Type="http://schemas.microsoft.com/office/2011/relationships/chartColorStyle" Target="colors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M$2:$M$9</c:f>
              <c:strCache>
                <c:ptCount val="8"/>
                <c:pt idx="0">
                  <c:v>N56</c:v>
                </c:pt>
                <c:pt idx="1">
                  <c:v>N58</c:v>
                </c:pt>
                <c:pt idx="2">
                  <c:v>N62</c:v>
                </c:pt>
                <c:pt idx="3">
                  <c:v>N63</c:v>
                </c:pt>
                <c:pt idx="4">
                  <c:v>N64</c:v>
                </c:pt>
                <c:pt idx="5">
                  <c:v>N65</c:v>
                </c:pt>
                <c:pt idx="6">
                  <c:v>N66</c:v>
                </c:pt>
                <c:pt idx="7">
                  <c:v>N67</c:v>
                </c:pt>
              </c:strCache>
            </c:strRef>
          </c:cat>
          <c:val>
            <c:numRef>
              <c:f>Sheet1!$U$2:$U$9</c:f>
              <c:numCache>
                <c:formatCode>0%</c:formatCode>
                <c:ptCount val="8"/>
                <c:pt idx="0">
                  <c:v>0.226480836236934</c:v>
                </c:pt>
                <c:pt idx="1">
                  <c:v>0.240121580547112</c:v>
                </c:pt>
                <c:pt idx="2">
                  <c:v>0.25</c:v>
                </c:pt>
                <c:pt idx="3">
                  <c:v>0.261261261261261</c:v>
                </c:pt>
                <c:pt idx="4">
                  <c:v>0.247761194029851</c:v>
                </c:pt>
                <c:pt idx="5">
                  <c:v>0.244776119402985</c:v>
                </c:pt>
                <c:pt idx="6">
                  <c:v>0.238372093023256</c:v>
                </c:pt>
                <c:pt idx="7">
                  <c:v>0.2151162790697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1"/>
        <c:overlap val="-27"/>
        <c:axId val="-1148868864"/>
        <c:axId val="-1146566192"/>
      </c:barChart>
      <c:catAx>
        <c:axId val="-11488688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+mn-cs"/>
              </a:defRPr>
            </a:pPr>
            <a:endParaRPr lang="en-US"/>
          </a:p>
        </c:txPr>
        <c:crossAx val="-1146566192"/>
        <c:crosses val="autoZero"/>
        <c:auto val="1"/>
        <c:lblAlgn val="ctr"/>
        <c:lblOffset val="100"/>
        <c:noMultiLvlLbl val="0"/>
      </c:catAx>
      <c:valAx>
        <c:axId val="-11465661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j-lt"/>
                    <a:ea typeface="+mn-ea"/>
                    <a:cs typeface="+mn-cs"/>
                  </a:defRPr>
                </a:pPr>
                <a:r>
                  <a:rPr lang="en-US"/>
                  <a:t>% known meQTLs detected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j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+mn-cs"/>
              </a:defRPr>
            </a:pPr>
            <a:endParaRPr lang="en-US"/>
          </a:p>
        </c:txPr>
        <c:crossAx val="-11488688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+mj-lt"/>
        </a:defRPr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E984FA-986C-3144-908B-FB5A182698FE}" type="datetimeFigureOut">
              <a:rPr lang="en-US" smtClean="0"/>
              <a:t>1/23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D0029B-3615-7D42-B5E6-9C9295FCC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4364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FEA0D-6E75-4F85-9066-4C5855EE9E9A}" type="datetimeFigureOut">
              <a:rPr lang="en-US" smtClean="0"/>
              <a:t>1/2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24A7F-C6B0-43FE-B5B9-7A89D17FAD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4187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FEA0D-6E75-4F85-9066-4C5855EE9E9A}" type="datetimeFigureOut">
              <a:rPr lang="en-US" smtClean="0"/>
              <a:t>1/2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24A7F-C6B0-43FE-B5B9-7A89D17FAD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169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FEA0D-6E75-4F85-9066-4C5855EE9E9A}" type="datetimeFigureOut">
              <a:rPr lang="en-US" smtClean="0"/>
              <a:t>1/2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24A7F-C6B0-43FE-B5B9-7A89D17FAD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3051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FEA0D-6E75-4F85-9066-4C5855EE9E9A}" type="datetimeFigureOut">
              <a:rPr lang="en-US" smtClean="0"/>
              <a:t>1/2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24A7F-C6B0-43FE-B5B9-7A89D17FAD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1867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FEA0D-6E75-4F85-9066-4C5855EE9E9A}" type="datetimeFigureOut">
              <a:rPr lang="en-US" smtClean="0"/>
              <a:t>1/2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24A7F-C6B0-43FE-B5B9-7A89D17FAD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1326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FEA0D-6E75-4F85-9066-4C5855EE9E9A}" type="datetimeFigureOut">
              <a:rPr lang="en-US" smtClean="0"/>
              <a:t>1/2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24A7F-C6B0-43FE-B5B9-7A89D17FAD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6481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FEA0D-6E75-4F85-9066-4C5855EE9E9A}" type="datetimeFigureOut">
              <a:rPr lang="en-US" smtClean="0"/>
              <a:t>1/23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24A7F-C6B0-43FE-B5B9-7A89D17FAD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39709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FEA0D-6E75-4F85-9066-4C5855EE9E9A}" type="datetimeFigureOut">
              <a:rPr lang="en-US" smtClean="0"/>
              <a:t>1/23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24A7F-C6B0-43FE-B5B9-7A89D17FAD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2761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FEA0D-6E75-4F85-9066-4C5855EE9E9A}" type="datetimeFigureOut">
              <a:rPr lang="en-US" smtClean="0"/>
              <a:t>1/23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24A7F-C6B0-43FE-B5B9-7A89D17FAD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94418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FEA0D-6E75-4F85-9066-4C5855EE9E9A}" type="datetimeFigureOut">
              <a:rPr lang="en-US" smtClean="0"/>
              <a:t>1/2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24A7F-C6B0-43FE-B5B9-7A89D17FAD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5323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FEA0D-6E75-4F85-9066-4C5855EE9E9A}" type="datetimeFigureOut">
              <a:rPr lang="en-US" smtClean="0"/>
              <a:t>1/2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24A7F-C6B0-43FE-B5B9-7A89D17FAD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6571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BFEA0D-6E75-4F85-9066-4C5855EE9E9A}" type="datetimeFigureOut">
              <a:rPr lang="en-US" smtClean="0"/>
              <a:t>1/2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624A7F-C6B0-43FE-B5B9-7A89D17FAD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2248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2.png"/><Relationship Id="rId3" Type="http://schemas.openxmlformats.org/officeDocument/2006/relationships/image" Target="../media/image23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4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png"/><Relationship Id="rId3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4" Type="http://schemas.openxmlformats.org/officeDocument/2006/relationships/image" Target="../media/image16.jpeg"/><Relationship Id="rId5" Type="http://schemas.openxmlformats.org/officeDocument/2006/relationships/image" Target="../media/image17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4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4" Type="http://schemas.openxmlformats.org/officeDocument/2006/relationships/image" Target="../media/image20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8.em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92764" y="5617786"/>
            <a:ext cx="1091406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 Detecting sample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tliers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Quality control of sequencing data generated was carried out in part by evaluating the histogram of percent methylation per base (blue) ad log</a:t>
            </a:r>
            <a:r>
              <a:rPr lang="en-US" sz="14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overage per base (green) for each sample. Samples deviating from the expected bimodal distribution (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of the former (</a:t>
            </a:r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,c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or demonstrating a non-continuous distribution for the latter (</a:t>
            </a:r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,e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were removed from analysis.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99293" y="322247"/>
            <a:ext cx="2971800" cy="237744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2859" y="322247"/>
            <a:ext cx="2971800" cy="237744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99293" y="3013827"/>
            <a:ext cx="2971800" cy="237744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2859" y="3013827"/>
            <a:ext cx="2971800" cy="237744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801633" y="250880"/>
            <a:ext cx="44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7994659" y="250880"/>
            <a:ext cx="44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4834816" y="2784907"/>
            <a:ext cx="4092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269720" y="2525726"/>
            <a:ext cx="1229343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dirty="0" smtClean="0"/>
              <a:t>% methylation per base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632355" y="2525726"/>
            <a:ext cx="1619702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dirty="0"/>
              <a:t>l</a:t>
            </a:r>
            <a:r>
              <a:rPr lang="en-US" sz="800" dirty="0" smtClean="0"/>
              <a:t>og</a:t>
            </a:r>
            <a:r>
              <a:rPr lang="en-US" sz="800" baseline="-25000" dirty="0" smtClean="0"/>
              <a:t>10</a:t>
            </a:r>
            <a:r>
              <a:rPr lang="en-US" sz="800" dirty="0" smtClean="0"/>
              <a:t>(read coverage) per base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8485061" y="2528715"/>
            <a:ext cx="1229343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dirty="0" smtClean="0"/>
              <a:t>% methylation per base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9847696" y="2528715"/>
            <a:ext cx="1619702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dirty="0"/>
              <a:t>l</a:t>
            </a:r>
            <a:r>
              <a:rPr lang="en-US" sz="800" dirty="0" smtClean="0"/>
              <a:t>og</a:t>
            </a:r>
            <a:r>
              <a:rPr lang="en-US" sz="800" baseline="-25000" dirty="0" smtClean="0"/>
              <a:t>10</a:t>
            </a:r>
            <a:r>
              <a:rPr lang="en-US" sz="800" dirty="0" smtClean="0"/>
              <a:t>(read coverage) per base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8027842" y="2784907"/>
            <a:ext cx="4092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e</a:t>
            </a:r>
            <a:endParaRPr lang="en-US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5362355" y="5218126"/>
            <a:ext cx="1229343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dirty="0" smtClean="0"/>
              <a:t>% methylation per base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6724990" y="5218126"/>
            <a:ext cx="1619702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dirty="0"/>
              <a:t>l</a:t>
            </a:r>
            <a:r>
              <a:rPr lang="en-US" sz="800" dirty="0" smtClean="0"/>
              <a:t>og</a:t>
            </a:r>
            <a:r>
              <a:rPr lang="en-US" sz="800" baseline="-25000" dirty="0" smtClean="0"/>
              <a:t>10</a:t>
            </a:r>
            <a:r>
              <a:rPr lang="en-US" sz="800" dirty="0" smtClean="0"/>
              <a:t>(read coverage) per base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8577696" y="5221115"/>
            <a:ext cx="1229343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dirty="0" smtClean="0"/>
              <a:t>% methylation per base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9940331" y="5221115"/>
            <a:ext cx="1619702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dirty="0"/>
              <a:t>l</a:t>
            </a:r>
            <a:r>
              <a:rPr lang="en-US" sz="800" dirty="0" smtClean="0"/>
              <a:t>og</a:t>
            </a:r>
            <a:r>
              <a:rPr lang="en-US" sz="800" baseline="-25000" dirty="0" smtClean="0"/>
              <a:t>10</a:t>
            </a:r>
            <a:r>
              <a:rPr lang="en-US" sz="800" dirty="0" smtClean="0"/>
              <a:t>(read coverage) per base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541" y="1360734"/>
            <a:ext cx="3845641" cy="3076513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730988" y="1141635"/>
            <a:ext cx="44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1256888" y="4221803"/>
            <a:ext cx="1229343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dirty="0" smtClean="0"/>
              <a:t>% methylation per base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953352" y="4221803"/>
            <a:ext cx="1619702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dirty="0"/>
              <a:t>l</a:t>
            </a:r>
            <a:r>
              <a:rPr lang="en-US" sz="800" dirty="0" smtClean="0"/>
              <a:t>og</a:t>
            </a:r>
            <a:r>
              <a:rPr lang="en-US" sz="800" baseline="-25000" dirty="0" smtClean="0"/>
              <a:t>10</a:t>
            </a:r>
            <a:r>
              <a:rPr lang="en-US" sz="800" dirty="0" smtClean="0"/>
              <a:t>(read coverage) per base 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288816" y="1143766"/>
            <a:ext cx="8370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Sample 11</a:t>
            </a:r>
            <a:endParaRPr lang="en-US" sz="1200" dirty="0"/>
          </a:p>
        </p:txBody>
      </p:sp>
      <p:sp>
        <p:nvSpPr>
          <p:cNvPr id="25" name="Rectangle 24"/>
          <p:cNvSpPr/>
          <p:nvPr/>
        </p:nvSpPr>
        <p:spPr>
          <a:xfrm>
            <a:off x="1394665" y="1641593"/>
            <a:ext cx="2560320" cy="914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5269720" y="521169"/>
            <a:ext cx="2560320" cy="914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Box 26"/>
          <p:cNvSpPr txBox="1"/>
          <p:nvPr/>
        </p:nvSpPr>
        <p:spPr>
          <a:xfrm>
            <a:off x="6084006" y="139969"/>
            <a:ext cx="8370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Sample 29</a:t>
            </a:r>
            <a:endParaRPr lang="en-US" sz="1200" dirty="0"/>
          </a:p>
        </p:txBody>
      </p:sp>
      <p:sp>
        <p:nvSpPr>
          <p:cNvPr id="28" name="Rectangle 27"/>
          <p:cNvSpPr/>
          <p:nvPr/>
        </p:nvSpPr>
        <p:spPr>
          <a:xfrm>
            <a:off x="8387336" y="524618"/>
            <a:ext cx="2560320" cy="914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TextBox 28"/>
          <p:cNvSpPr txBox="1"/>
          <p:nvPr/>
        </p:nvSpPr>
        <p:spPr>
          <a:xfrm>
            <a:off x="9262537" y="143418"/>
            <a:ext cx="8370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Sample 59</a:t>
            </a:r>
            <a:endParaRPr lang="en-US" sz="1200" dirty="0"/>
          </a:p>
        </p:txBody>
      </p:sp>
      <p:sp>
        <p:nvSpPr>
          <p:cNvPr id="30" name="Rectangle 29"/>
          <p:cNvSpPr/>
          <p:nvPr/>
        </p:nvSpPr>
        <p:spPr>
          <a:xfrm>
            <a:off x="5411073" y="3215321"/>
            <a:ext cx="2560320" cy="914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Box 30"/>
          <p:cNvSpPr txBox="1"/>
          <p:nvPr/>
        </p:nvSpPr>
        <p:spPr>
          <a:xfrm>
            <a:off x="6084006" y="2855424"/>
            <a:ext cx="8370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Sample 65</a:t>
            </a:r>
            <a:endParaRPr lang="en-US" sz="1200" dirty="0"/>
          </a:p>
        </p:txBody>
      </p:sp>
      <p:sp>
        <p:nvSpPr>
          <p:cNvPr id="32" name="Rectangle 31"/>
          <p:cNvSpPr/>
          <p:nvPr/>
        </p:nvSpPr>
        <p:spPr>
          <a:xfrm>
            <a:off x="8444464" y="3257927"/>
            <a:ext cx="2560320" cy="914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/>
          <p:cNvSpPr txBox="1"/>
          <p:nvPr/>
        </p:nvSpPr>
        <p:spPr>
          <a:xfrm>
            <a:off x="9262537" y="2855424"/>
            <a:ext cx="8370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Sample 42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56974989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85551" y="5683972"/>
            <a:ext cx="1091406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 Functional enrichment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sting at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stone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rks from a </a:t>
            </a:r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ymphoblastoid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ell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e (LCL)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or each genomic category, effect of enrichment (log odds ratio) is plotted across increasingly stringent differential methylation analysis p-value cutoffs (x-axis). Enrichment within a genomic category is indicated with the color yellow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unctional enrichment testing demonstrates no significant enrichment at any of the histone marks tested from data generated from a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uman LCL (GM12878).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74002" y="1841929"/>
            <a:ext cx="1179871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l</a:t>
            </a:r>
            <a:r>
              <a:rPr lang="en-US" sz="1400" dirty="0" smtClean="0"/>
              <a:t>og</a:t>
            </a:r>
            <a:r>
              <a:rPr lang="en-US" sz="1400" baseline="-25000" dirty="0" smtClean="0"/>
              <a:t>10</a:t>
            </a:r>
            <a:r>
              <a:rPr lang="en-US" sz="1400" dirty="0" smtClean="0"/>
              <a:t>(OR)</a:t>
            </a:r>
            <a:endParaRPr lang="en-US" sz="1400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76745" y="201889"/>
            <a:ext cx="5283200" cy="5549900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 flipH="1" flipV="1">
            <a:off x="2570763" y="4706263"/>
            <a:ext cx="4636556" cy="979171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2918165" y="4621046"/>
            <a:ext cx="1060398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2200" dirty="0" smtClean="0"/>
              <a:t>0.05</a:t>
            </a:r>
            <a:endParaRPr lang="en-US" sz="2200" dirty="0"/>
          </a:p>
        </p:txBody>
      </p:sp>
      <p:sp>
        <p:nvSpPr>
          <p:cNvPr id="10" name="TextBox 9"/>
          <p:cNvSpPr txBox="1"/>
          <p:nvPr/>
        </p:nvSpPr>
        <p:spPr>
          <a:xfrm>
            <a:off x="4264133" y="4620450"/>
            <a:ext cx="1229343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2200" dirty="0" smtClean="0"/>
              <a:t>5x10</a:t>
            </a:r>
            <a:r>
              <a:rPr lang="en-US" sz="2200" baseline="30000" dirty="0" smtClean="0"/>
              <a:t>-3</a:t>
            </a:r>
            <a:endParaRPr lang="en-US" sz="2200" baseline="30000" dirty="0"/>
          </a:p>
        </p:txBody>
      </p:sp>
      <p:sp>
        <p:nvSpPr>
          <p:cNvPr id="11" name="TextBox 10"/>
          <p:cNvSpPr txBox="1"/>
          <p:nvPr/>
        </p:nvSpPr>
        <p:spPr>
          <a:xfrm>
            <a:off x="5487685" y="4604556"/>
            <a:ext cx="1229343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2200" dirty="0" smtClean="0"/>
              <a:t>5x10</a:t>
            </a:r>
            <a:r>
              <a:rPr lang="en-US" sz="2200" baseline="30000" dirty="0" smtClean="0"/>
              <a:t>-4</a:t>
            </a:r>
            <a:endParaRPr lang="en-US" sz="2200" baseline="30000" dirty="0"/>
          </a:p>
        </p:txBody>
      </p:sp>
      <p:sp>
        <p:nvSpPr>
          <p:cNvPr id="12" name="TextBox 11"/>
          <p:cNvSpPr txBox="1"/>
          <p:nvPr/>
        </p:nvSpPr>
        <p:spPr>
          <a:xfrm>
            <a:off x="2779201" y="5078927"/>
            <a:ext cx="418328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2000" dirty="0" smtClean="0"/>
              <a:t>Differential Methylation p-value cutoff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870452" y="5400489"/>
            <a:ext cx="117987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t">
            <a:spAutoFit/>
          </a:bodyPr>
          <a:lstStyle/>
          <a:p>
            <a:pPr algn="ctr"/>
            <a:r>
              <a:rPr lang="en-US" sz="1200" dirty="0"/>
              <a:t>l</a:t>
            </a:r>
            <a:r>
              <a:rPr lang="en-US" sz="1200" dirty="0" smtClean="0"/>
              <a:t>og</a:t>
            </a:r>
            <a:r>
              <a:rPr lang="en-US" sz="1200" baseline="-25000" dirty="0" smtClean="0"/>
              <a:t>10</a:t>
            </a:r>
            <a:r>
              <a:rPr lang="en-US" sz="1200" dirty="0" smtClean="0"/>
              <a:t>(OR)</a:t>
            </a:r>
            <a:endParaRPr lang="en-US" sz="1200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46370" y="4482357"/>
            <a:ext cx="1132376" cy="10039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309055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11209" y="483699"/>
            <a:ext cx="4351338" cy="435133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20853" y="4988232"/>
            <a:ext cx="109140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 Power calculation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rve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Given the sample size and variation within the data, we were 80% powered to detect a mean methylation difference between cases and controls greater than 2.6% in our differential methylation analysi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36500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93149" y="4461338"/>
            <a:ext cx="1091406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 Null distributions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For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oth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CpH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ites the null distribution – as determined by 1000 residual bootstraps --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or percentage of sites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permethylated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is indicated by the curved lines at the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hree p-value cutoffs for differential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ethylation. Dotted vertical lines indicate study-wide significance (p&lt;0.05). For each p-value cutoff, solid lines to the right of the dotted line indicate significant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permethylation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6027" y="956187"/>
            <a:ext cx="5638800" cy="338328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1923" y="956187"/>
            <a:ext cx="5638800" cy="338328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11157" y="956187"/>
            <a:ext cx="44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6164827" y="956187"/>
            <a:ext cx="44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156041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1596502"/>
              </p:ext>
            </p:extLst>
          </p:nvPr>
        </p:nvGraphicFramePr>
        <p:xfrm>
          <a:off x="2510094" y="612059"/>
          <a:ext cx="6794500" cy="40766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443352" y="4825903"/>
            <a:ext cx="1091406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 Published </a:t>
            </a:r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QTLs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elp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entify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mple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tliers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Samples identified as outliers using surrogate variable analysis (SVA) were removed from analysis one at a time. The percentage of known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QTLs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y-axis) was detected iteratively. 63 samples were utilized in these analyses as this maximized the percent of previously-published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QTLs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identified.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05377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2232" y="3008920"/>
            <a:ext cx="5852160" cy="292608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7943" y="215011"/>
            <a:ext cx="5852160" cy="292608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807" r="6088"/>
          <a:stretch/>
        </p:blipFill>
        <p:spPr>
          <a:xfrm>
            <a:off x="1396278" y="215011"/>
            <a:ext cx="3303084" cy="2926080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913530" y="123809"/>
            <a:ext cx="44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4424766" y="123809"/>
            <a:ext cx="44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520853" y="6063794"/>
            <a:ext cx="109140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 Cytosine summary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 Average methylation distribution for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H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sites included for analysis. Genomic context (</a:t>
            </a:r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,e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and proximity to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Islands (</a:t>
            </a:r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,f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are also summarized for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H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sites, respectively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7297087" y="123809"/>
            <a:ext cx="44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913530" y="2850754"/>
            <a:ext cx="44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7297087" y="2850754"/>
            <a:ext cx="44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</a:t>
            </a:r>
            <a:endParaRPr lang="en-US" b="1" dirty="0"/>
          </a:p>
        </p:txBody>
      </p:sp>
      <p:pic>
        <p:nvPicPr>
          <p:cNvPr id="2" name="Picture 1" descr="Hist_N63_20L_nonCpG.png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907"/>
          <a:stretch/>
        </p:blipFill>
        <p:spPr>
          <a:xfrm>
            <a:off x="1425788" y="3008920"/>
            <a:ext cx="3479578" cy="292608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4424766" y="2850754"/>
            <a:ext cx="44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e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52059535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3554" y="110836"/>
            <a:ext cx="9372600" cy="53213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495421" y="608716"/>
            <a:ext cx="44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3" name="TextBox 2"/>
          <p:cNvSpPr txBox="1"/>
          <p:nvPr/>
        </p:nvSpPr>
        <p:spPr>
          <a:xfrm>
            <a:off x="6253566" y="608716"/>
            <a:ext cx="44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652822" y="4908916"/>
            <a:ext cx="1091406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 Percent Methylation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 The overall percent methylation for each sample within the (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and (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H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context is plotted. In the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context, the median percent methylation is lower and more variable in the controls relative to cases. However, within the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H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context, cases and controls are largely comparable.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81956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20852" y="4896464"/>
            <a:ext cx="1091406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 Correlation between RRBS and 27K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ray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a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For the sites measured directly by methyl sequencing (RRBS) and methylation array (27K array), the mean methylation across samples was measured. These values are plotted and the correlation (R</a:t>
            </a:r>
            <a:r>
              <a:rPr lang="en-US" sz="14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is indicated by the dotted line. 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2619" y="0"/>
            <a:ext cx="4871224" cy="48712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6408746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0052" y="86499"/>
            <a:ext cx="7800633" cy="252924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0853" y="2722853"/>
            <a:ext cx="7799832" cy="252898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03123" y="152611"/>
            <a:ext cx="44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8387842" y="66112"/>
            <a:ext cx="44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403123" y="2722853"/>
            <a:ext cx="44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8387842" y="2636354"/>
            <a:ext cx="44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d</a:t>
            </a:r>
            <a:endParaRPr 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520853" y="5496232"/>
            <a:ext cx="1091406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 Single site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fferential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thylation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alysis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Manhattan Plots for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H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tes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demonstrate no individual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tosines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were significant after multiple testing correction. Genomic Position is plotted along the x-axis with significance along the y-axis. Cutoff for significance was determined empirically by residual bootstrapping and is indicated by the green dotted line. QQ plots for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H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sites are colored by mean methylation for each site.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9497961" y="66112"/>
            <a:ext cx="1160207" cy="27801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9400564" y="2636354"/>
            <a:ext cx="1160207" cy="27801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61578" y="369592"/>
            <a:ext cx="2395728" cy="2395728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61578" y="3005686"/>
            <a:ext cx="2395728" cy="23957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912322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25112" y="4230043"/>
            <a:ext cx="109140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 Methylation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tterns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 previously reported DMRs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ethylation percentages for case (red) and control (black) individuals are plotted for the three regions from Ladd-Acosta et. al</a:t>
            </a:r>
            <a:r>
              <a:rPr lang="en-US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or which which we have coverage within the RRBS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data. </a:t>
            </a:r>
            <a:endParaRPr 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5112" y="1273755"/>
            <a:ext cx="3657599" cy="256032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47199" y="1273755"/>
            <a:ext cx="3657599" cy="256032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69285" y="1273755"/>
            <a:ext cx="3657600" cy="256032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371643" y="1089089"/>
            <a:ext cx="44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3" name="TextBox 2"/>
          <p:cNvSpPr txBox="1"/>
          <p:nvPr/>
        </p:nvSpPr>
        <p:spPr>
          <a:xfrm>
            <a:off x="4350597" y="1089089"/>
            <a:ext cx="44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8329551" y="1089089"/>
            <a:ext cx="44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33602658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HyperEnrichment_total_methdiff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764"/>
          <a:stretch/>
        </p:blipFill>
        <p:spPr>
          <a:xfrm>
            <a:off x="2495176" y="74702"/>
            <a:ext cx="7620000" cy="5378824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670610" y="5265619"/>
            <a:ext cx="1091406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permethylation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ignal in </a:t>
            </a:r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H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ites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creases with methylation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fferences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tween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ses and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ntrols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he proportion of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permethylated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sites is plotted along the y-axis. Groups along the x-axis are broken down my differential p-value cutoff. For each p-value cutoff, three further cutoffs were imposed to determine the proportion of methylated sites without any minimal requirement for methylation difference (0%), a 5% difference in methylation between cases and controls, or a 10% difference.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101565" y="4156631"/>
            <a:ext cx="1060398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2200" dirty="0" smtClean="0"/>
              <a:t>0.05</a:t>
            </a:r>
            <a:endParaRPr lang="en-US" sz="2200" dirty="0"/>
          </a:p>
        </p:txBody>
      </p:sp>
      <p:sp>
        <p:nvSpPr>
          <p:cNvPr id="7" name="TextBox 6"/>
          <p:cNvSpPr txBox="1"/>
          <p:nvPr/>
        </p:nvSpPr>
        <p:spPr>
          <a:xfrm>
            <a:off x="5965422" y="4156631"/>
            <a:ext cx="1229343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2200" dirty="0" smtClean="0"/>
              <a:t>5x10</a:t>
            </a:r>
            <a:r>
              <a:rPr lang="en-US" sz="2200" baseline="30000" dirty="0" smtClean="0"/>
              <a:t>-3</a:t>
            </a:r>
            <a:endParaRPr lang="en-US" sz="2200" baseline="30000" dirty="0"/>
          </a:p>
        </p:txBody>
      </p:sp>
      <p:sp>
        <p:nvSpPr>
          <p:cNvPr id="8" name="TextBox 7"/>
          <p:cNvSpPr txBox="1"/>
          <p:nvPr/>
        </p:nvSpPr>
        <p:spPr>
          <a:xfrm>
            <a:off x="7912898" y="4156631"/>
            <a:ext cx="1229343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2200" dirty="0" smtClean="0"/>
              <a:t>5x10</a:t>
            </a:r>
            <a:r>
              <a:rPr lang="en-US" sz="2200" baseline="30000" dirty="0" smtClean="0"/>
              <a:t>-4</a:t>
            </a:r>
            <a:endParaRPr lang="en-US" sz="2200" baseline="30000" dirty="0"/>
          </a:p>
        </p:txBody>
      </p:sp>
      <p:sp>
        <p:nvSpPr>
          <p:cNvPr id="9" name="TextBox 8"/>
          <p:cNvSpPr txBox="1"/>
          <p:nvPr/>
        </p:nvSpPr>
        <p:spPr>
          <a:xfrm>
            <a:off x="4452613" y="4645629"/>
            <a:ext cx="418328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2000" dirty="0" smtClean="0"/>
              <a:t>Differential Methylation p-value cutoff</a:t>
            </a:r>
          </a:p>
        </p:txBody>
      </p:sp>
      <p:cxnSp>
        <p:nvCxnSpPr>
          <p:cNvPr id="11" name="Straight Connector 10"/>
          <p:cNvCxnSpPr/>
          <p:nvPr/>
        </p:nvCxnSpPr>
        <p:spPr>
          <a:xfrm flipV="1">
            <a:off x="3824941" y="4156631"/>
            <a:ext cx="1613647" cy="14941"/>
          </a:xfrm>
          <a:prstGeom prst="lin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 flipV="1">
            <a:off x="7720746" y="4156631"/>
            <a:ext cx="1613647" cy="14941"/>
          </a:xfrm>
          <a:prstGeom prst="lin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 flipV="1">
            <a:off x="5773270" y="4156631"/>
            <a:ext cx="1613647" cy="14941"/>
          </a:xfrm>
          <a:prstGeom prst="lin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7705376" y="64394"/>
            <a:ext cx="1060398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1400" dirty="0"/>
              <a:t>m</a:t>
            </a:r>
            <a:r>
              <a:rPr lang="en-US" sz="1400" dirty="0" smtClean="0"/>
              <a:t>ethylation difference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2182903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Blank Presentation">
    <a:majorFont>
      <a:latin typeface="Arial"/>
      <a:ea typeface="ＭＳ Ｐゴシック"/>
      <a:cs typeface=""/>
    </a:majorFont>
    <a:minorFont>
      <a:latin typeface="Arial"/>
      <a:ea typeface="ＭＳ Ｐゴシック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6600</TotalTime>
  <Words>809</Words>
  <Application>Microsoft Macintosh PowerPoint</Application>
  <PresentationFormat>Widescreen</PresentationFormat>
  <Paragraphs>60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Calibri</vt:lpstr>
      <vt:lpstr>Calibri Light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llis</dc:creator>
  <cp:lastModifiedBy>sellis18@jhmi.edu</cp:lastModifiedBy>
  <cp:revision>76</cp:revision>
  <cp:lastPrinted>2016-06-06T18:18:25Z</cp:lastPrinted>
  <dcterms:created xsi:type="dcterms:W3CDTF">2016-06-02T12:00:05Z</dcterms:created>
  <dcterms:modified xsi:type="dcterms:W3CDTF">2017-01-23T19:49:01Z</dcterms:modified>
</cp:coreProperties>
</file>